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9" d="100"/>
          <a:sy n="89" d="100"/>
        </p:scale>
        <p:origin x="8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1CFF530-5D9E-48A5-898E-4CA359782D4C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499979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91" t="14917" r="26734" b="10104"/>
          <a:stretch/>
        </p:blipFill>
        <p:spPr>
          <a:xfrm>
            <a:off x="2209799" y="2219325"/>
            <a:ext cx="5565913" cy="32575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307A501-452C-23BC-7824-8B88784D6324}"/>
              </a:ext>
            </a:extLst>
          </p:cNvPr>
          <p:cNvSpPr txBox="1"/>
          <p:nvPr/>
        </p:nvSpPr>
        <p:spPr>
          <a:xfrm>
            <a:off x="3396299" y="608222"/>
            <a:ext cx="32658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4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344573" y="1702206"/>
            <a:ext cx="64860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VIS MBM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q</a:t>
            </a: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uantification of the 2</a:t>
            </a:r>
            <a:r>
              <a:rPr kumimoji="0" lang="en-US" sz="2000" b="1" i="0" u="none" strike="noStrike" kern="1200" cap="none" spc="0" normalizeH="0" baseline="3000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d</a:t>
            </a: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generation CDXs</a:t>
            </a:r>
            <a:endParaRPr kumimoji="0" 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1428259" y="2228850"/>
            <a:ext cx="8232232" cy="3903107"/>
            <a:chOff x="1513984" y="1905000"/>
            <a:chExt cx="8232232" cy="3903107"/>
          </a:xfrm>
        </p:grpSpPr>
        <p:sp>
          <p:nvSpPr>
            <p:cNvPr id="4" name="TextBox 3"/>
            <p:cNvSpPr txBox="1"/>
            <p:nvPr/>
          </p:nvSpPr>
          <p:spPr>
            <a:xfrm>
              <a:off x="7766187" y="2102614"/>
              <a:ext cx="1980029" cy="15850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9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uNBSGW</a:t>
              </a:r>
              <a:r>
                <a:rPr kumimoji="0" lang="en-US" sz="1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blood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9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BSGW blood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9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uNBSGW</a:t>
              </a:r>
              <a:r>
                <a:rPr kumimoji="0" lang="en-US" sz="1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brain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9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BSGW brain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020718" y="1905000"/>
              <a:ext cx="312906" cy="32624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5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6</a:t>
              </a: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50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5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4</a:t>
              </a: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50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5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2</a:t>
              </a: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50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5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  <a:endPara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527239" y="3339583"/>
              <a:ext cx="23428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Total flux (p/s x 10</a:t>
              </a:r>
              <a:r>
                <a:rPr kumimoji="0" lang="en-US" sz="1800" b="1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6</a:t>
              </a:r>
              <a:r>
                <a:rPr kumimoji="0" lang="en-US" sz="1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)</a:t>
              </a:r>
              <a:endPara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199774" y="5438775"/>
              <a:ext cx="9114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eeks</a:t>
              </a:r>
              <a:endPara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787604" y="5100757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</a:t>
              </a:r>
              <a:endPara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905495" y="5100757"/>
              <a:ext cx="3129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018161" y="5100757"/>
              <a:ext cx="3129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182968" y="5100757"/>
              <a:ext cx="2190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8</a:t>
              </a:r>
              <a:endPara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265282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35</Words>
  <Application>Microsoft Office PowerPoint</Application>
  <PresentationFormat>Custom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Kyana N Montoya</cp:lastModifiedBy>
  <cp:revision>15</cp:revision>
  <dcterms:created xsi:type="dcterms:W3CDTF">2024-11-19T17:14:58Z</dcterms:created>
  <dcterms:modified xsi:type="dcterms:W3CDTF">2024-11-19T17:42:31Z</dcterms:modified>
</cp:coreProperties>
</file>